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 varScale="1">
        <p:scale>
          <a:sx n="43" d="100"/>
          <a:sy n="43" d="100"/>
        </p:scale>
        <p:origin x="2520" y="60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3893416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2450" y="4456586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| Classification of enriched reactions from Sister species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a pairwise comparison analysis and classification of the reactions expanded or overexpressed in at least 50% of the Sister specie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e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% of the 32 Sister species, or 50% of the related Sisters from Steppe or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). B</a:t>
            </a:r>
            <a:r>
              <a:rPr lang="en-GB" sz="800" b="0" i="0" u="none" strike="noStrike" cap="none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iochemical pathways were defined based on </a:t>
            </a:r>
            <a:r>
              <a:rPr lang="en-GB" sz="800" b="0" i="0" u="none" strike="noStrike" cap="none" dirty="0" err="1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MetaCyc</a:t>
            </a:r>
            <a:r>
              <a:rPr lang="en-GB" sz="800" b="0" i="0" u="none" strike="noStrike" cap="none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 and </a:t>
            </a:r>
            <a:r>
              <a:rPr lang="en-GB" sz="800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KEGG data.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6"/>
            <a:ext cx="5760000" cy="3908505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3" name="Graphique 2">
            <a:extLst>
              <a:ext uri="{FF2B5EF4-FFF2-40B4-BE49-F238E27FC236}">
                <a16:creationId xmlns:a16="http://schemas.microsoft.com/office/drawing/2014/main" id="{6ED68013-46F7-0F17-55DE-523580EFE3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484538" y="749845"/>
            <a:ext cx="3600000" cy="3474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56058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73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2:08Z</dcterms:modified>
</cp:coreProperties>
</file>